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31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61C28685-4324-844F-9B12-1A6C1C26EF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85360" y="0"/>
            <a:ext cx="7406640" cy="6858000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1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534237B-1B11-CE4B-87A4-69DEC3C1A157}"/>
              </a:ext>
            </a:extLst>
          </p:cNvPr>
          <p:cNvSpPr txBox="1"/>
          <p:nvPr/>
        </p:nvSpPr>
        <p:spPr>
          <a:xfrm>
            <a:off x="9537894" y="3749041"/>
            <a:ext cx="10134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1L Platinum Chem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112BAA3-51E2-B14D-9AA6-0C99FB07280A}"/>
              </a:ext>
            </a:extLst>
          </p:cNvPr>
          <p:cNvSpPr txBox="1"/>
          <p:nvPr/>
        </p:nvSpPr>
        <p:spPr>
          <a:xfrm>
            <a:off x="9537893" y="328248"/>
            <a:ext cx="10134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1L Platinum Chemo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A0F92A-EE79-0845-9E97-C336FF379E9C}"/>
              </a:ext>
            </a:extLst>
          </p:cNvPr>
          <p:cNvSpPr txBox="1"/>
          <p:nvPr/>
        </p:nvSpPr>
        <p:spPr>
          <a:xfrm>
            <a:off x="5842780" y="3763574"/>
            <a:ext cx="10134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1L Platinum Chem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75E6132-A023-2149-93A3-BB5EE5F787AF}"/>
              </a:ext>
            </a:extLst>
          </p:cNvPr>
          <p:cNvSpPr txBox="1"/>
          <p:nvPr/>
        </p:nvSpPr>
        <p:spPr>
          <a:xfrm>
            <a:off x="5842779" y="342781"/>
            <a:ext cx="10134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>
                <a:solidFill>
                  <a:srgbClr val="FF4C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1L Single-agent ICPI</a:t>
            </a:r>
          </a:p>
          <a:p>
            <a:r>
              <a:rPr lang="en-US" sz="800" b="1">
                <a:latin typeface="Calibri" panose="020F0502020204030204" pitchFamily="34" charset="0"/>
                <a:cs typeface="Calibri" panose="020F0502020204030204" pitchFamily="34" charset="0"/>
              </a:rPr>
              <a:t>1L Platinum Chem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D3FDF7A-B81A-9B46-8879-1691C981B7D5}"/>
              </a:ext>
            </a:extLst>
          </p:cNvPr>
          <p:cNvSpPr txBox="1"/>
          <p:nvPr/>
        </p:nvSpPr>
        <p:spPr>
          <a:xfrm>
            <a:off x="4562560" y="0"/>
            <a:ext cx="4908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E95884B-0B5F-1444-8D36-CC6BCBEC2B1B}"/>
              </a:ext>
            </a:extLst>
          </p:cNvPr>
          <p:cNvSpPr txBox="1"/>
          <p:nvPr/>
        </p:nvSpPr>
        <p:spPr>
          <a:xfrm>
            <a:off x="8309307" y="0"/>
            <a:ext cx="481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449E84D-4EFD-1243-8F29-30F66A4B39EC}"/>
              </a:ext>
            </a:extLst>
          </p:cNvPr>
          <p:cNvSpPr txBox="1"/>
          <p:nvPr/>
        </p:nvSpPr>
        <p:spPr>
          <a:xfrm>
            <a:off x="4562560" y="3416747"/>
            <a:ext cx="4780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B00AA22-B86E-1A4E-B484-6D128D928AF9}"/>
              </a:ext>
            </a:extLst>
          </p:cNvPr>
          <p:cNvSpPr txBox="1"/>
          <p:nvPr/>
        </p:nvSpPr>
        <p:spPr>
          <a:xfrm>
            <a:off x="8309307" y="3416747"/>
            <a:ext cx="4988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D)</a:t>
            </a:r>
          </a:p>
        </p:txBody>
      </p:sp>
      <p:sp>
        <p:nvSpPr>
          <p:cNvPr id="18" name="Content Placeholder 1">
            <a:extLst>
              <a:ext uri="{FF2B5EF4-FFF2-40B4-BE49-F238E27FC236}">
                <a16:creationId xmlns:a16="http://schemas.microsoft.com/office/drawing/2014/main" id="{F8841C7B-387E-6347-AEA3-0DDF2C0A4E82}"/>
              </a:ext>
            </a:extLst>
          </p:cNvPr>
          <p:cNvSpPr txBox="1">
            <a:spLocks/>
          </p:cNvSpPr>
          <p:nvPr/>
        </p:nvSpPr>
        <p:spPr>
          <a:xfrm>
            <a:off x="286531" y="2100069"/>
            <a:ext cx="4002124" cy="3442602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Unadjusted for known treatment assignment imbalances, patients receiving 1</a:t>
            </a:r>
            <a:r>
              <a:rPr lang="en-US" sz="1400" b="1" baseline="30000" dirty="0">
                <a:latin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 line ICPI vs. chemotherapy have more favorable outcomes when TMB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≥ </a:t>
            </a: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10 but not TMB &lt; 10.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Kaplan-Meier curves are unadjusted for imbalances (propensity weights applied). TTNT is shown by drug class for (A) TMB &lt; 10, and (B) TMB ≥ 10. OS is shown by drug class for (C) TMB &lt; 10, and (D) TMB ≥ 10. X-axis is truncated at 36 months. Overall survival estimates are left truncated (see Methods) with at-risk tables adjusted accordingly. Interaction models can be found in Supplemental Figure 9.</a:t>
            </a:r>
          </a:p>
        </p:txBody>
      </p:sp>
    </p:spTree>
    <p:extLst>
      <p:ext uri="{BB962C8B-B14F-4D97-AF65-F5344CB8AC3E}">
        <p14:creationId xmlns:p14="http://schemas.microsoft.com/office/powerpoint/2010/main" val="748987379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56</Words>
  <Application>Microsoft Macintosh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10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13</cp:revision>
  <dcterms:created xsi:type="dcterms:W3CDTF">2022-06-12T16:24:02Z</dcterms:created>
  <dcterms:modified xsi:type="dcterms:W3CDTF">2022-08-13T14:35:30Z</dcterms:modified>
</cp:coreProperties>
</file>